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4" r:id="rId3"/>
    <p:sldId id="259" r:id="rId4"/>
    <p:sldId id="265" r:id="rId5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88E8DF6-65A3-483C-979C-7DFBCAF3C5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C812794E-D844-447F-931D-E866CFE3A9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9450DAC-166B-4642-8258-168B83F9AF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FC76E-038C-4F4C-95EA-32C715FAEC3B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90544AC-EDF8-48F6-9AF1-5D5CDC3904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0E1C4E5-2A56-4102-99BA-5794450EDB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750CE-645A-4D24-AFB5-3CD2A3C419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91763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10C3446-424D-4FF6-B7A2-32538C4AF1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F72CAA41-1F07-4F44-82F9-C1DD6DCF56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4C85F54-9C71-40A2-877F-357F280AB8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FC76E-038C-4F4C-95EA-32C715FAEC3B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7D4AC66-6E8E-4C17-9249-681F5EB14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DE7BE1A-0D26-4A5A-A0C6-4347F6E99D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750CE-645A-4D24-AFB5-3CD2A3C419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9950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C774EB7B-48D0-44BD-B1F3-67438905C3D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D5ADC8B-232F-403B-9B6D-C086A22703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61766E6-4253-4A28-8661-B40AD94564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FC76E-038C-4F4C-95EA-32C715FAEC3B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3E5C06C-17B6-4446-874B-F1B63C289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16624B0-5CD2-47E6-BD3F-B2D197BEAA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750CE-645A-4D24-AFB5-3CD2A3C419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701754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2776AE3-7A8A-4BE3-BA79-585798A8EF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2D9A5FC-5D0B-4277-8D03-EACA2F1029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79A44EC-5867-40F0-81F2-60715154E8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FC76E-038C-4F4C-95EA-32C715FAEC3B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4EEC733-31B5-4F84-BEE6-8B966ED211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4CBF13B-6C57-4D01-9F98-BB1F1EE57B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750CE-645A-4D24-AFB5-3CD2A3C419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45192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03FE075-244A-4073-BD6A-825768C6E4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61E6351-4C79-4885-8DA0-2CFF6C2700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CB3B6DA-A24E-4063-B147-AEAE3BD27A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FC76E-038C-4F4C-95EA-32C715FAEC3B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885404B-E247-4EE6-A375-FB82C1FB3F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444797B-5A37-45DD-9A1F-D1789B14B9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750CE-645A-4D24-AFB5-3CD2A3C419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984556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84E9A00-788A-4DF3-BDC6-0182BDC604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53ED859-8FE1-41B2-8465-16CC54BAF4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A15CB04-4998-44B7-A8A3-C6E230CC89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EB78E5D-29CB-4776-A7C2-0815AF9E9A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FC76E-038C-4F4C-95EA-32C715FAEC3B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B36925C-4A1D-41C1-BC1D-A048540271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9EF5536-B036-4A7C-8732-0BA2E5FD66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750CE-645A-4D24-AFB5-3CD2A3C419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4501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450D039-F53B-463E-ABE1-A6F3B7B4F2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8563EDD-605C-4789-BBC1-B620154852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D240BDC-D00A-4A06-B42C-BD73334A08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263C9E97-9355-43DD-88DD-6BDB864167C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747BAC56-1C94-4854-9532-EA891B9E3E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6C9BFFC9-B1EB-4A38-B81A-FE0EFE40CF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FC76E-038C-4F4C-95EA-32C715FAEC3B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EB41E55B-1805-4F8B-B536-4665D71F9F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8025DBC2-B80E-4C60-95EA-4678AFA8C6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750CE-645A-4D24-AFB5-3CD2A3C419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929307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96A59D3-86B6-44E1-8881-69EBB88022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F089EA25-6CD2-45DF-A04D-A39DCF5F0A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FC76E-038C-4F4C-95EA-32C715FAEC3B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26B29B3C-63B9-46C4-91B1-3E138649A9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273F3819-1612-4B1C-85F0-B605F4F6E7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750CE-645A-4D24-AFB5-3CD2A3C419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0706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30961BCA-AF28-4548-B783-7E6D51D199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FC76E-038C-4F4C-95EA-32C715FAEC3B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13DF5301-4817-4A53-A815-CFD4798C57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4F33AAD3-4DD9-4D98-B25A-71F0FD2ED1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750CE-645A-4D24-AFB5-3CD2A3C419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4811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81EDFCE-27D6-4189-8ED9-94145DD518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5052B36-CF98-4581-8EF2-98A498C530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C15D4FC4-BF83-4D0F-AC45-25EF5BBBD1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A5C6094-DB67-4B8D-942D-9651571F61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FC76E-038C-4F4C-95EA-32C715FAEC3B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FCB4227-4E05-451C-B57F-D935BF201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23066A4-7C61-4858-B3A2-F8FD865567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750CE-645A-4D24-AFB5-3CD2A3C419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2756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AB9A8EF-5CCA-424D-B8EE-889F5EDBD9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E23D5884-30A9-4BBC-82F3-81586A78FF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D170EA75-43CF-417C-A8A4-D4826D7DDD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A56F7C5-62EA-486D-8780-DCDEEFB8B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FC76E-038C-4F4C-95EA-32C715FAEC3B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DAAA1D0-0648-4F32-B4B6-1C90684A4C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9D11489-2B59-457D-A0A7-511D1F7958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750CE-645A-4D24-AFB5-3CD2A3C419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9933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95239CD9-E93D-49C6-ABA3-E68BAD9A4C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4BEFAC0-ED8B-4276-81F7-7B687452BE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ED61416-8209-43C8-AE5B-93E0F6E2C5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1FC76E-038C-4F4C-95EA-32C715FAEC3B}" type="datetimeFigureOut">
              <a:rPr lang="ko-KR" altLang="en-US" smtClean="0"/>
              <a:t>2023-11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EBE247E-8310-48E3-AB7A-A21FCC89381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1581D26-F972-473F-98AD-FC079FFEEBE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B750CE-645A-4D24-AFB5-3CD2A3C4195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45140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" name="Group 50"/>
          <p:cNvGrpSpPr/>
          <p:nvPr/>
        </p:nvGrpSpPr>
        <p:grpSpPr>
          <a:xfrm>
            <a:off x="1151359" y="2058884"/>
            <a:ext cx="8737667" cy="3590242"/>
            <a:chOff x="623858" y="976041"/>
            <a:chExt cx="8737667" cy="3590242"/>
          </a:xfrm>
        </p:grpSpPr>
        <p:graphicFrame>
          <p:nvGraphicFramePr>
            <p:cNvPr id="41" name="Object 40">
              <a:extLst>
                <a:ext uri="{FF2B5EF4-FFF2-40B4-BE49-F238E27FC236}">
                  <a16:creationId xmlns:a16="http://schemas.microsoft.com/office/drawing/2014/main" id="{722BEF31-1581-4A7A-BEF5-A2470514A1F2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2036941" y="1085918"/>
            <a:ext cx="2288100" cy="187477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6" name="CS ChemDraw Drawing" r:id="rId3" imgW="3673983" imgH="3009519" progId="ChemDraw.Document.6.0">
                    <p:embed/>
                  </p:oleObj>
                </mc:Choice>
                <mc:Fallback>
                  <p:oleObj name="CS ChemDraw Drawing" r:id="rId3" imgW="3673983" imgH="3009519" progId="ChemDraw.Document.6.0">
                    <p:embed/>
                    <p:pic>
                      <p:nvPicPr>
                        <p:cNvPr id="41" name="Object 40">
                          <a:extLst>
                            <a:ext uri="{FF2B5EF4-FFF2-40B4-BE49-F238E27FC236}">
                              <a16:creationId xmlns:a16="http://schemas.microsoft.com/office/drawing/2014/main" id="{722BEF31-1581-4A7A-BEF5-A2470514A1F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036941" y="1085918"/>
                          <a:ext cx="2288100" cy="187477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42" name="Straight Arrow Connector 41"/>
            <p:cNvCxnSpPr/>
            <p:nvPr/>
          </p:nvCxnSpPr>
          <p:spPr>
            <a:xfrm>
              <a:off x="4620950" y="2183090"/>
              <a:ext cx="1998133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Rectangle 42"/>
            <p:cNvSpPr/>
            <p:nvPr/>
          </p:nvSpPr>
          <p:spPr>
            <a:xfrm>
              <a:off x="4620950" y="1830475"/>
              <a:ext cx="1981633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AG acetyltransferases (AACs)</a:t>
              </a:r>
            </a:p>
          </p:txBody>
        </p:sp>
        <p:sp>
          <p:nvSpPr>
            <p:cNvPr id="44" name="Arc 43"/>
            <p:cNvSpPr/>
            <p:nvPr/>
          </p:nvSpPr>
          <p:spPr>
            <a:xfrm rot="19026092">
              <a:off x="4333779" y="2197343"/>
              <a:ext cx="2415311" cy="2368940"/>
            </a:xfrm>
            <a:prstGeom prst="arc">
              <a:avLst>
                <a:gd name="adj1" fmla="val 16200000"/>
                <a:gd name="adj2" fmla="val 166207"/>
              </a:avLst>
            </a:prstGeom>
            <a:ln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aphicFrame>
          <p:nvGraphicFramePr>
            <p:cNvPr id="45" name="Object 44">
              <a:extLst>
                <a:ext uri="{FF2B5EF4-FFF2-40B4-BE49-F238E27FC236}">
                  <a16:creationId xmlns:a16="http://schemas.microsoft.com/office/drawing/2014/main" id="{59A0751E-D72B-4E43-AF5B-7A6D63E75E6D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7087226" y="976041"/>
            <a:ext cx="2274299" cy="187477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7" name="CS ChemDraw Drawing" r:id="rId5" imgW="3673983" imgH="3036951" progId="ChemDraw.Document.6.0">
                    <p:embed/>
                  </p:oleObj>
                </mc:Choice>
                <mc:Fallback>
                  <p:oleObj name="CS ChemDraw Drawing" r:id="rId5" imgW="3673983" imgH="3036951" progId="ChemDraw.Document.6.0">
                    <p:embed/>
                    <p:pic>
                      <p:nvPicPr>
                        <p:cNvPr id="45" name="Object 44">
                          <a:extLst>
                            <a:ext uri="{FF2B5EF4-FFF2-40B4-BE49-F238E27FC236}">
                              <a16:creationId xmlns:a16="http://schemas.microsoft.com/office/drawing/2014/main" id="{59A0751E-D72B-4E43-AF5B-7A6D63E75E6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7087226" y="976041"/>
                          <a:ext cx="2274299" cy="187477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6" name="Rectangle 45"/>
            <p:cNvSpPr/>
            <p:nvPr/>
          </p:nvSpPr>
          <p:spPr>
            <a:xfrm>
              <a:off x="2848926" y="2952411"/>
              <a:ext cx="853119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Kanamycin</a:t>
              </a:r>
            </a:p>
          </p:txBody>
        </p:sp>
        <p:sp>
          <p:nvSpPr>
            <p:cNvPr id="47" name="Rectangle 46"/>
            <p:cNvSpPr/>
            <p:nvPr/>
          </p:nvSpPr>
          <p:spPr>
            <a:xfrm>
              <a:off x="7626950" y="2940914"/>
              <a:ext cx="1497526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3-N-Acetyl kanamycin</a:t>
              </a:r>
            </a:p>
          </p:txBody>
        </p:sp>
        <p:sp>
          <p:nvSpPr>
            <p:cNvPr id="48" name="Rectangle 47"/>
            <p:cNvSpPr/>
            <p:nvPr/>
          </p:nvSpPr>
          <p:spPr>
            <a:xfrm>
              <a:off x="4340129" y="2476718"/>
              <a:ext cx="851515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Acetyl CoA</a:t>
              </a:r>
            </a:p>
          </p:txBody>
        </p:sp>
        <p:sp>
          <p:nvSpPr>
            <p:cNvPr id="49" name="Rectangle 48"/>
            <p:cNvSpPr/>
            <p:nvPr/>
          </p:nvSpPr>
          <p:spPr>
            <a:xfrm>
              <a:off x="6138582" y="2556361"/>
              <a:ext cx="635110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CoASH</a:t>
              </a:r>
            </a:p>
          </p:txBody>
        </p:sp>
        <p:sp>
          <p:nvSpPr>
            <p:cNvPr id="50" name="Rectangle 49"/>
            <p:cNvSpPr/>
            <p:nvPr/>
          </p:nvSpPr>
          <p:spPr>
            <a:xfrm>
              <a:off x="623858" y="3747995"/>
              <a:ext cx="3795598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" name="직사각형 13">
            <a:extLst>
              <a:ext uri="{FF2B5EF4-FFF2-40B4-BE49-F238E27FC236}">
                <a16:creationId xmlns:a16="http://schemas.microsoft.com/office/drawing/2014/main" id="{F6325413-A4AB-43CA-B6E0-3658876D76D2}"/>
              </a:ext>
            </a:extLst>
          </p:cNvPr>
          <p:cNvSpPr/>
          <p:nvPr/>
        </p:nvSpPr>
        <p:spPr>
          <a:xfrm>
            <a:off x="1295878" y="1719385"/>
            <a:ext cx="228810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</a:rPr>
              <a:t>Supplementary figure 1</a:t>
            </a:r>
            <a:endParaRPr lang="ko-KR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8612770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39">
            <a:extLst>
              <a:ext uri="{FF2B5EF4-FFF2-40B4-BE49-F238E27FC236}">
                <a16:creationId xmlns:a16="http://schemas.microsoft.com/office/drawing/2014/main" id="{5B649CD8-00EB-438F-AEEA-FCBFD34E01C8}"/>
              </a:ext>
            </a:extLst>
          </p:cNvPr>
          <p:cNvGrpSpPr/>
          <p:nvPr/>
        </p:nvGrpSpPr>
        <p:grpSpPr>
          <a:xfrm>
            <a:off x="2428819" y="2390767"/>
            <a:ext cx="7334361" cy="3352603"/>
            <a:chOff x="2113644" y="3852569"/>
            <a:chExt cx="7334361" cy="3352603"/>
          </a:xfrm>
        </p:grpSpPr>
        <p:grpSp>
          <p:nvGrpSpPr>
            <p:cNvPr id="3" name="Group 37">
              <a:extLst>
                <a:ext uri="{FF2B5EF4-FFF2-40B4-BE49-F238E27FC236}">
                  <a16:creationId xmlns:a16="http://schemas.microsoft.com/office/drawing/2014/main" id="{7580B688-1DBC-4DEF-8BB7-999D68180249}"/>
                </a:ext>
              </a:extLst>
            </p:cNvPr>
            <p:cNvGrpSpPr/>
            <p:nvPr/>
          </p:nvGrpSpPr>
          <p:grpSpPr>
            <a:xfrm>
              <a:off x="2113644" y="3852569"/>
              <a:ext cx="7334361" cy="3352603"/>
              <a:chOff x="2099576" y="4443412"/>
              <a:chExt cx="7334361" cy="3352603"/>
            </a:xfrm>
          </p:grpSpPr>
          <p:graphicFrame>
            <p:nvGraphicFramePr>
              <p:cNvPr id="5" name="Object 3">
                <a:extLst>
                  <a:ext uri="{FF2B5EF4-FFF2-40B4-BE49-F238E27FC236}">
                    <a16:creationId xmlns:a16="http://schemas.microsoft.com/office/drawing/2014/main" id="{A60ADC42-13AD-4B84-8239-87147C902A24}"/>
                  </a:ext>
                </a:extLst>
              </p:cNvPr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2099576" y="4443412"/>
              <a:ext cx="2503964" cy="212248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50" name="CS ChemDraw Drawing" r:id="rId3" imgW="3751707" imgH="3180207" progId="ChemDraw.Document.6.0">
                      <p:embed/>
                    </p:oleObj>
                  </mc:Choice>
                  <mc:Fallback>
                    <p:oleObj name="CS ChemDraw Drawing" r:id="rId3" imgW="3751707" imgH="3180207" progId="ChemDraw.Document.6.0">
                      <p:embed/>
                      <p:pic>
                        <p:nvPicPr>
                          <p:cNvPr id="5" name="Object 3">
                            <a:extLst>
                              <a:ext uri="{FF2B5EF4-FFF2-40B4-BE49-F238E27FC236}">
                                <a16:creationId xmlns:a16="http://schemas.microsoft.com/office/drawing/2014/main" id="{A60ADC42-13AD-4B84-8239-87147C902A2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2099576" y="4443412"/>
                            <a:ext cx="2503964" cy="212248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6" name="Object 4">
                <a:extLst>
                  <a:ext uri="{FF2B5EF4-FFF2-40B4-BE49-F238E27FC236}">
                    <a16:creationId xmlns:a16="http://schemas.microsoft.com/office/drawing/2014/main" id="{74C3433A-D669-43E6-9AF4-FC5CFC91DEF4}"/>
                  </a:ext>
                </a:extLst>
              </p:cNvPr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7036326" y="4443412"/>
              <a:ext cx="2397611" cy="212248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51" name="CS ChemDraw Drawing" r:id="rId5" imgW="3750183" imgH="3180207" progId="ChemDraw.Document.6.0">
                      <p:embed/>
                    </p:oleObj>
                  </mc:Choice>
                  <mc:Fallback>
                    <p:oleObj name="CS ChemDraw Drawing" r:id="rId5" imgW="3750183" imgH="3180207" progId="ChemDraw.Document.6.0">
                      <p:embed/>
                      <p:pic>
                        <p:nvPicPr>
                          <p:cNvPr id="6" name="Object 4">
                            <a:extLst>
                              <a:ext uri="{FF2B5EF4-FFF2-40B4-BE49-F238E27FC236}">
                                <a16:creationId xmlns:a16="http://schemas.microsoft.com/office/drawing/2014/main" id="{74C3433A-D669-43E6-9AF4-FC5CFC91DEF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7036326" y="4443412"/>
                            <a:ext cx="2397611" cy="212248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cxnSp>
            <p:nvCxnSpPr>
              <p:cNvPr id="7" name="Straight Arrow Connector 6">
                <a:extLst>
                  <a:ext uri="{FF2B5EF4-FFF2-40B4-BE49-F238E27FC236}">
                    <a16:creationId xmlns:a16="http://schemas.microsoft.com/office/drawing/2014/main" id="{FC703947-178C-43CE-A0A4-8CF83D6DBD9C}"/>
                  </a:ext>
                </a:extLst>
              </p:cNvPr>
              <p:cNvCxnSpPr/>
              <p:nvPr/>
            </p:nvCxnSpPr>
            <p:spPr>
              <a:xfrm>
                <a:off x="4766733" y="5412822"/>
                <a:ext cx="199813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294608DC-D281-48BF-A903-5CD2CE05D656}"/>
                  </a:ext>
                </a:extLst>
              </p:cNvPr>
              <p:cNvSpPr/>
              <p:nvPr/>
            </p:nvSpPr>
            <p:spPr>
              <a:xfrm>
                <a:off x="4848686" y="5102842"/>
                <a:ext cx="1677062" cy="253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AG phosphotransferases</a:t>
                </a:r>
              </a:p>
            </p:txBody>
          </p:sp>
          <p:sp>
            <p:nvSpPr>
              <p:cNvPr id="9" name="Arc 31">
                <a:extLst>
                  <a:ext uri="{FF2B5EF4-FFF2-40B4-BE49-F238E27FC236}">
                    <a16:creationId xmlns:a16="http://schemas.microsoft.com/office/drawing/2014/main" id="{A14FF6FF-37DF-40B3-B977-4665DA1187EB}"/>
                  </a:ext>
                </a:extLst>
              </p:cNvPr>
              <p:cNvSpPr/>
              <p:nvPr/>
            </p:nvSpPr>
            <p:spPr>
              <a:xfrm rot="19026092">
                <a:off x="4479562" y="5427075"/>
                <a:ext cx="2415311" cy="2368940"/>
              </a:xfrm>
              <a:prstGeom prst="arc">
                <a:avLst>
                  <a:gd name="adj1" fmla="val 16200000"/>
                  <a:gd name="adj2" fmla="val 166207"/>
                </a:avLst>
              </a:prstGeom>
              <a:ln>
                <a:solidFill>
                  <a:schemeClr val="tx1"/>
                </a:solidFill>
                <a:headEnd type="none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Rectangle 32">
                <a:extLst>
                  <a:ext uri="{FF2B5EF4-FFF2-40B4-BE49-F238E27FC236}">
                    <a16:creationId xmlns:a16="http://schemas.microsoft.com/office/drawing/2014/main" id="{3A4F7A8C-BF18-4D0B-97EE-489332DB85F5}"/>
                  </a:ext>
                </a:extLst>
              </p:cNvPr>
              <p:cNvSpPr/>
              <p:nvPr/>
            </p:nvSpPr>
            <p:spPr>
              <a:xfrm>
                <a:off x="4546961" y="5770892"/>
                <a:ext cx="445956" cy="253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ATP</a:t>
                </a:r>
              </a:p>
            </p:txBody>
          </p:sp>
          <p:sp>
            <p:nvSpPr>
              <p:cNvPr id="11" name="Rectangle 33">
                <a:extLst>
                  <a:ext uri="{FF2B5EF4-FFF2-40B4-BE49-F238E27FC236}">
                    <a16:creationId xmlns:a16="http://schemas.microsoft.com/office/drawing/2014/main" id="{EE4513CE-AAC1-4782-A982-97D058DFDB9A}"/>
                  </a:ext>
                </a:extLst>
              </p:cNvPr>
              <p:cNvSpPr/>
              <p:nvPr/>
            </p:nvSpPr>
            <p:spPr>
              <a:xfrm>
                <a:off x="6402941" y="5796966"/>
                <a:ext cx="461986" cy="253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ADP</a:t>
                </a:r>
              </a:p>
            </p:txBody>
          </p:sp>
          <p:sp>
            <p:nvSpPr>
              <p:cNvPr id="12" name="Rectangle 35">
                <a:extLst>
                  <a:ext uri="{FF2B5EF4-FFF2-40B4-BE49-F238E27FC236}">
                    <a16:creationId xmlns:a16="http://schemas.microsoft.com/office/drawing/2014/main" id="{09688767-C4DF-44CA-8905-0BB9782188E5}"/>
                  </a:ext>
                </a:extLst>
              </p:cNvPr>
              <p:cNvSpPr/>
              <p:nvPr/>
            </p:nvSpPr>
            <p:spPr>
              <a:xfrm>
                <a:off x="3088644" y="6627557"/>
                <a:ext cx="971741" cy="253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Streptomycin</a:t>
                </a:r>
              </a:p>
            </p:txBody>
          </p:sp>
          <p:sp>
            <p:nvSpPr>
              <p:cNvPr id="13" name="Rectangle 36">
                <a:extLst>
                  <a:ext uri="{FF2B5EF4-FFF2-40B4-BE49-F238E27FC236}">
                    <a16:creationId xmlns:a16="http://schemas.microsoft.com/office/drawing/2014/main" id="{854D3FE2-01D2-4B5B-92A1-CBDFE9BF24EB}"/>
                  </a:ext>
                </a:extLst>
              </p:cNvPr>
              <p:cNvSpPr/>
              <p:nvPr/>
            </p:nvSpPr>
            <p:spPr>
              <a:xfrm>
                <a:off x="7581119" y="6627557"/>
                <a:ext cx="1850186" cy="253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Streptomycin (6)-phosphate</a:t>
                </a:r>
              </a:p>
            </p:txBody>
          </p:sp>
        </p:grpSp>
        <p:sp>
          <p:nvSpPr>
            <p:cNvPr id="4" name="Rectangle 38">
              <a:extLst>
                <a:ext uri="{FF2B5EF4-FFF2-40B4-BE49-F238E27FC236}">
                  <a16:creationId xmlns:a16="http://schemas.microsoft.com/office/drawing/2014/main" id="{E1A2D649-74B4-4A6F-98E4-715A37A3D6EE}"/>
                </a:ext>
              </a:extLst>
            </p:cNvPr>
            <p:cNvSpPr/>
            <p:nvPr/>
          </p:nvSpPr>
          <p:spPr>
            <a:xfrm>
              <a:off x="4125016" y="6361447"/>
              <a:ext cx="3795598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31DC53B1-4BA1-471A-8A06-BE8DE216EE60}"/>
              </a:ext>
            </a:extLst>
          </p:cNvPr>
          <p:cNvSpPr/>
          <p:nvPr/>
        </p:nvSpPr>
        <p:spPr>
          <a:xfrm>
            <a:off x="1295878" y="1719385"/>
            <a:ext cx="228810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</a:rPr>
              <a:t>Supplementary figure 2</a:t>
            </a:r>
            <a:endParaRPr lang="ko-KR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0946843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488852D2-19F2-4F3F-AC85-ED23BF46ED7C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3314949" y="2603865"/>
          <a:ext cx="1204913" cy="1103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4" name="CS ChemDraw Drawing" r:id="rId3" imgW="1205103" imgH="1102995" progId="ChemDraw.Document.6.0">
                  <p:embed/>
                </p:oleObj>
              </mc:Choice>
              <mc:Fallback>
                <p:oleObj name="CS ChemDraw Drawing" r:id="rId3" imgW="1205103" imgH="1102995" progId="ChemDraw.Document.6.0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488852D2-19F2-4F3F-AC85-ED23BF46ED7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314949" y="2603865"/>
                        <a:ext cx="1204913" cy="1103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D996A62D-7810-4E6A-98CC-8515A3E652A5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7137500" y="2676096"/>
          <a:ext cx="1365250" cy="958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" name="CS ChemDraw Drawing" r:id="rId5" imgW="1365123" imgH="958215" progId="ChemDraw.Document.6.0">
                  <p:embed/>
                </p:oleObj>
              </mc:Choice>
              <mc:Fallback>
                <p:oleObj name="CS ChemDraw Drawing" r:id="rId5" imgW="1365123" imgH="958215" progId="ChemDraw.Document.6.0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D996A62D-7810-4E6A-98CC-8515A3E652A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137500" y="2676096"/>
                        <a:ext cx="1365250" cy="958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6" name="Straight Arrow Connector 5"/>
          <p:cNvCxnSpPr/>
          <p:nvPr/>
        </p:nvCxnSpPr>
        <p:spPr>
          <a:xfrm>
            <a:off x="4787504" y="3185043"/>
            <a:ext cx="199813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ectangle 6"/>
          <p:cNvSpPr/>
          <p:nvPr/>
        </p:nvSpPr>
        <p:spPr>
          <a:xfrm>
            <a:off x="5373636" y="2931127"/>
            <a:ext cx="922047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sz="105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-lactamase</a:t>
            </a:r>
          </a:p>
        </p:txBody>
      </p:sp>
      <p:sp>
        <p:nvSpPr>
          <p:cNvPr id="15" name="Rectangle 14"/>
          <p:cNvSpPr/>
          <p:nvPr/>
        </p:nvSpPr>
        <p:spPr>
          <a:xfrm>
            <a:off x="3465197" y="3725387"/>
            <a:ext cx="966931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sz="105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-lactam ring</a:t>
            </a:r>
          </a:p>
        </p:txBody>
      </p:sp>
      <p:sp>
        <p:nvSpPr>
          <p:cNvPr id="16" name="Rectangle 15"/>
          <p:cNvSpPr/>
          <p:nvPr/>
        </p:nvSpPr>
        <p:spPr>
          <a:xfrm>
            <a:off x="7346493" y="3779410"/>
            <a:ext cx="1205779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Inactive </a:t>
            </a:r>
            <a:r>
              <a:rPr lang="el-GR" sz="105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-lactam</a:t>
            </a:r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id="{9F6F571F-AE79-4E67-9A8D-D0EEBD237E69}"/>
              </a:ext>
            </a:extLst>
          </p:cNvPr>
          <p:cNvSpPr/>
          <p:nvPr/>
        </p:nvSpPr>
        <p:spPr>
          <a:xfrm>
            <a:off x="1295878" y="1719385"/>
            <a:ext cx="228810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</a:rPr>
              <a:t>Supplementary figure 3</a:t>
            </a:r>
            <a:endParaRPr lang="ko-KR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7749416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6">
            <a:extLst>
              <a:ext uri="{FF2B5EF4-FFF2-40B4-BE49-F238E27FC236}">
                <a16:creationId xmlns:a16="http://schemas.microsoft.com/office/drawing/2014/main" id="{B09E8793-BD49-4B7B-825F-BFDECE639354}"/>
              </a:ext>
            </a:extLst>
          </p:cNvPr>
          <p:cNvGrpSpPr/>
          <p:nvPr/>
        </p:nvGrpSpPr>
        <p:grpSpPr>
          <a:xfrm>
            <a:off x="973394" y="1485618"/>
            <a:ext cx="10688932" cy="3886763"/>
            <a:chOff x="1081678" y="2709830"/>
            <a:chExt cx="10688932" cy="3886763"/>
          </a:xfrm>
        </p:grpSpPr>
        <p:graphicFrame>
          <p:nvGraphicFramePr>
            <p:cNvPr id="3" name="Object 9">
              <a:extLst>
                <a:ext uri="{FF2B5EF4-FFF2-40B4-BE49-F238E27FC236}">
                  <a16:creationId xmlns:a16="http://schemas.microsoft.com/office/drawing/2014/main" id="{9AA48A22-3140-45CC-9B99-4BE13AB28025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1081678" y="3176930"/>
            <a:ext cx="3903632" cy="225329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098" name="CS ChemDraw Drawing" r:id="rId3" imgW="5354955" imgH="3090291" progId="ChemDraw.Document.6.0">
                    <p:embed/>
                  </p:oleObj>
                </mc:Choice>
                <mc:Fallback>
                  <p:oleObj name="CS ChemDraw Drawing" r:id="rId3" imgW="5354955" imgH="3090291" progId="ChemDraw.Document.6.0">
                    <p:embed/>
                    <p:pic>
                      <p:nvPicPr>
                        <p:cNvPr id="3" name="Object 9">
                          <a:extLst>
                            <a:ext uri="{FF2B5EF4-FFF2-40B4-BE49-F238E27FC236}">
                              <a16:creationId xmlns:a16="http://schemas.microsoft.com/office/drawing/2014/main" id="{9AA48A22-3140-45CC-9B99-4BE13AB2802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081678" y="3176930"/>
                          <a:ext cx="3903632" cy="225329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4" name="Group 13">
              <a:extLst>
                <a:ext uri="{FF2B5EF4-FFF2-40B4-BE49-F238E27FC236}">
                  <a16:creationId xmlns:a16="http://schemas.microsoft.com/office/drawing/2014/main" id="{3512B8A5-8670-4D46-8690-512F9ABD47DB}"/>
                </a:ext>
              </a:extLst>
            </p:cNvPr>
            <p:cNvGrpSpPr/>
            <p:nvPr/>
          </p:nvGrpSpPr>
          <p:grpSpPr>
            <a:xfrm>
              <a:off x="7402195" y="2709830"/>
              <a:ext cx="4368415" cy="2819513"/>
              <a:chOff x="6925235" y="2158253"/>
              <a:chExt cx="4368415" cy="2819513"/>
            </a:xfrm>
          </p:grpSpPr>
          <p:graphicFrame>
            <p:nvGraphicFramePr>
              <p:cNvPr id="14" name="Object 10">
                <a:extLst>
                  <a:ext uri="{FF2B5EF4-FFF2-40B4-BE49-F238E27FC236}">
                    <a16:creationId xmlns:a16="http://schemas.microsoft.com/office/drawing/2014/main" id="{C37E6FA2-4984-4C82-A242-C7DA27912560}"/>
                  </a:ext>
                </a:extLst>
              </p:cNvPr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7050332" y="2248536"/>
              <a:ext cx="4243318" cy="272923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099" name="CS ChemDraw Drawing" r:id="rId5" imgW="6264783" imgH="4029075" progId="ChemDraw.Document.6.0">
                      <p:embed/>
                    </p:oleObj>
                  </mc:Choice>
                  <mc:Fallback>
                    <p:oleObj name="CS ChemDraw Drawing" r:id="rId5" imgW="6264783" imgH="4029075" progId="ChemDraw.Document.6.0">
                      <p:embed/>
                      <p:pic>
                        <p:nvPicPr>
                          <p:cNvPr id="14" name="Object 10">
                            <a:extLst>
                              <a:ext uri="{FF2B5EF4-FFF2-40B4-BE49-F238E27FC236}">
                                <a16:creationId xmlns:a16="http://schemas.microsoft.com/office/drawing/2014/main" id="{C37E6FA2-4984-4C82-A242-C7DA2791256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7050332" y="2248536"/>
                            <a:ext cx="4243318" cy="272923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5" name="Rectangle 11">
                <a:extLst>
                  <a:ext uri="{FF2B5EF4-FFF2-40B4-BE49-F238E27FC236}">
                    <a16:creationId xmlns:a16="http://schemas.microsoft.com/office/drawing/2014/main" id="{CA82508D-9397-4AA8-ABFB-17C3B4CEAED5}"/>
                  </a:ext>
                </a:extLst>
              </p:cNvPr>
              <p:cNvSpPr/>
              <p:nvPr/>
            </p:nvSpPr>
            <p:spPr>
              <a:xfrm>
                <a:off x="6925235" y="2158253"/>
                <a:ext cx="322730" cy="2286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Rectangle 12">
                <a:extLst>
                  <a:ext uri="{FF2B5EF4-FFF2-40B4-BE49-F238E27FC236}">
                    <a16:creationId xmlns:a16="http://schemas.microsoft.com/office/drawing/2014/main" id="{54E2B3D4-4A39-42D7-B593-FFC6B75A6401}"/>
                  </a:ext>
                </a:extLst>
              </p:cNvPr>
              <p:cNvSpPr/>
              <p:nvPr/>
            </p:nvSpPr>
            <p:spPr>
              <a:xfrm>
                <a:off x="7058831" y="2158253"/>
                <a:ext cx="367408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7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DP</a:t>
                </a:r>
              </a:p>
            </p:txBody>
          </p:sp>
        </p:grpSp>
        <p:grpSp>
          <p:nvGrpSpPr>
            <p:cNvPr id="5" name="Group 21">
              <a:extLst>
                <a:ext uri="{FF2B5EF4-FFF2-40B4-BE49-F238E27FC236}">
                  <a16:creationId xmlns:a16="http://schemas.microsoft.com/office/drawing/2014/main" id="{792AE38A-5D30-4AF9-9704-4EAAAE94A72A}"/>
                </a:ext>
              </a:extLst>
            </p:cNvPr>
            <p:cNvGrpSpPr/>
            <p:nvPr/>
          </p:nvGrpSpPr>
          <p:grpSpPr>
            <a:xfrm>
              <a:off x="5094629" y="3959484"/>
              <a:ext cx="2665926" cy="2637109"/>
              <a:chOff x="4699085" y="4140977"/>
              <a:chExt cx="2665926" cy="2637109"/>
            </a:xfrm>
          </p:grpSpPr>
          <p:cxnSp>
            <p:nvCxnSpPr>
              <p:cNvPr id="9" name="Straight Arrow Connector 16">
                <a:extLst>
                  <a:ext uri="{FF2B5EF4-FFF2-40B4-BE49-F238E27FC236}">
                    <a16:creationId xmlns:a16="http://schemas.microsoft.com/office/drawing/2014/main" id="{0E5E2188-3134-437F-9109-B3034F74A318}"/>
                  </a:ext>
                </a:extLst>
              </p:cNvPr>
              <p:cNvCxnSpPr/>
              <p:nvPr/>
            </p:nvCxnSpPr>
            <p:spPr>
              <a:xfrm>
                <a:off x="4986256" y="4394893"/>
                <a:ext cx="199813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Rectangle 17">
                <a:extLst>
                  <a:ext uri="{FF2B5EF4-FFF2-40B4-BE49-F238E27FC236}">
                    <a16:creationId xmlns:a16="http://schemas.microsoft.com/office/drawing/2014/main" id="{79BA5960-1F40-4BED-9E67-2BE31B3C3419}"/>
                  </a:ext>
                </a:extLst>
              </p:cNvPr>
              <p:cNvSpPr/>
              <p:nvPr/>
            </p:nvSpPr>
            <p:spPr>
              <a:xfrm>
                <a:off x="5573991" y="4140977"/>
                <a:ext cx="873957" cy="253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Arr enzyme</a:t>
                </a:r>
              </a:p>
            </p:txBody>
          </p:sp>
          <p:sp>
            <p:nvSpPr>
              <p:cNvPr id="11" name="Arc 18">
                <a:extLst>
                  <a:ext uri="{FF2B5EF4-FFF2-40B4-BE49-F238E27FC236}">
                    <a16:creationId xmlns:a16="http://schemas.microsoft.com/office/drawing/2014/main" id="{05F7629B-39EC-44BD-A306-1005B2E283CD}"/>
                  </a:ext>
                </a:extLst>
              </p:cNvPr>
              <p:cNvSpPr/>
              <p:nvPr/>
            </p:nvSpPr>
            <p:spPr>
              <a:xfrm rot="19026092">
                <a:off x="4699085" y="4409146"/>
                <a:ext cx="2415311" cy="2368940"/>
              </a:xfrm>
              <a:prstGeom prst="arc">
                <a:avLst>
                  <a:gd name="adj1" fmla="val 16200000"/>
                  <a:gd name="adj2" fmla="val 166207"/>
                </a:avLst>
              </a:prstGeom>
              <a:ln>
                <a:solidFill>
                  <a:schemeClr val="tx1"/>
                </a:solidFill>
                <a:headEnd type="none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Rectangle 19">
                <a:extLst>
                  <a:ext uri="{FF2B5EF4-FFF2-40B4-BE49-F238E27FC236}">
                    <a16:creationId xmlns:a16="http://schemas.microsoft.com/office/drawing/2014/main" id="{1CC6154B-9803-46F2-AD7A-979E1AEA5C54}"/>
                  </a:ext>
                </a:extLst>
              </p:cNvPr>
              <p:cNvSpPr/>
              <p:nvPr/>
            </p:nvSpPr>
            <p:spPr>
              <a:xfrm>
                <a:off x="4766484" y="4752963"/>
                <a:ext cx="529312" cy="253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NAD</a:t>
                </a:r>
                <a:r>
                  <a:rPr lang="en-US" sz="105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Rectangle 20">
                <a:extLst>
                  <a:ext uri="{FF2B5EF4-FFF2-40B4-BE49-F238E27FC236}">
                    <a16:creationId xmlns:a16="http://schemas.microsoft.com/office/drawing/2014/main" id="{827DEB65-B1B7-440D-90D6-6997C918F47F}"/>
                  </a:ext>
                </a:extLst>
              </p:cNvPr>
              <p:cNvSpPr/>
              <p:nvPr/>
            </p:nvSpPr>
            <p:spPr>
              <a:xfrm>
                <a:off x="6398080" y="4752963"/>
                <a:ext cx="966931" cy="253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Nicotinamide</a:t>
                </a:r>
              </a:p>
            </p:txBody>
          </p:sp>
        </p:grpSp>
        <p:sp>
          <p:nvSpPr>
            <p:cNvPr id="6" name="Rectangle 22">
              <a:extLst>
                <a:ext uri="{FF2B5EF4-FFF2-40B4-BE49-F238E27FC236}">
                  <a16:creationId xmlns:a16="http://schemas.microsoft.com/office/drawing/2014/main" id="{98D92D19-774C-4444-8896-ACE80FFCA687}"/>
                </a:ext>
              </a:extLst>
            </p:cNvPr>
            <p:cNvSpPr/>
            <p:nvPr/>
          </p:nvSpPr>
          <p:spPr>
            <a:xfrm>
              <a:off x="5352841" y="5926333"/>
              <a:ext cx="3795598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Rectangle 24">
              <a:extLst>
                <a:ext uri="{FF2B5EF4-FFF2-40B4-BE49-F238E27FC236}">
                  <a16:creationId xmlns:a16="http://schemas.microsoft.com/office/drawing/2014/main" id="{B7013EFD-766E-47F3-B6BF-544D44AF73FA}"/>
                </a:ext>
              </a:extLst>
            </p:cNvPr>
            <p:cNvSpPr/>
            <p:nvPr/>
          </p:nvSpPr>
          <p:spPr>
            <a:xfrm>
              <a:off x="2365957" y="5529343"/>
              <a:ext cx="816249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Rifampicin</a:t>
              </a:r>
            </a:p>
          </p:txBody>
        </p:sp>
        <p:sp>
          <p:nvSpPr>
            <p:cNvPr id="8" name="Rectangle 25">
              <a:extLst>
                <a:ext uri="{FF2B5EF4-FFF2-40B4-BE49-F238E27FC236}">
                  <a16:creationId xmlns:a16="http://schemas.microsoft.com/office/drawing/2014/main" id="{1C2FE391-BC73-4EF8-BAE8-40A8291CD8A9}"/>
                </a:ext>
              </a:extLst>
            </p:cNvPr>
            <p:cNvSpPr/>
            <p:nvPr/>
          </p:nvSpPr>
          <p:spPr>
            <a:xfrm>
              <a:off x="9427625" y="5627015"/>
              <a:ext cx="1476686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ADP-ribosylrifampicin</a:t>
              </a:r>
            </a:p>
          </p:txBody>
        </p:sp>
      </p:grpSp>
      <p:sp>
        <p:nvSpPr>
          <p:cNvPr id="19" name="직사각형 18">
            <a:extLst>
              <a:ext uri="{FF2B5EF4-FFF2-40B4-BE49-F238E27FC236}">
                <a16:creationId xmlns:a16="http://schemas.microsoft.com/office/drawing/2014/main" id="{8ADB5FBA-FB84-406B-AED5-DB8A4686F645}"/>
              </a:ext>
            </a:extLst>
          </p:cNvPr>
          <p:cNvSpPr/>
          <p:nvPr/>
        </p:nvSpPr>
        <p:spPr>
          <a:xfrm>
            <a:off x="529674" y="1422012"/>
            <a:ext cx="228810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</a:rPr>
              <a:t>Supplementary figure 4</a:t>
            </a:r>
            <a:endParaRPr lang="ko-KR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3994741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Office PowerPoint</Application>
  <PresentationFormat>와이드스크린</PresentationFormat>
  <Paragraphs>23</Paragraphs>
  <Slides>4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8" baseType="lpstr">
      <vt:lpstr>맑은 고딕</vt:lpstr>
      <vt:lpstr>Arial</vt:lpstr>
      <vt:lpstr>Office 테마</vt:lpstr>
      <vt:lpstr>CS ChemDraw Drawing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1</cp:revision>
  <dcterms:created xsi:type="dcterms:W3CDTF">2023-11-01T04:44:37Z</dcterms:created>
  <dcterms:modified xsi:type="dcterms:W3CDTF">2023-11-01T04:44:50Z</dcterms:modified>
</cp:coreProperties>
</file>